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840" y="6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832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658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515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44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0517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956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361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368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797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52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518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769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DB7239A-3570-42DC-A309-3E9785EB7D4D}"/>
              </a:ext>
            </a:extLst>
          </p:cNvPr>
          <p:cNvSpPr txBox="1"/>
          <p:nvPr/>
        </p:nvSpPr>
        <p:spPr>
          <a:xfrm>
            <a:off x="1363387" y="4947252"/>
            <a:ext cx="751298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Fig. S5</a:t>
            </a:r>
            <a:r>
              <a:rPr lang="en-US" sz="1400" dirty="0"/>
              <a:t> Predicted grain Zn concentrations using the full training set (n=253) compared to the training set excluding potentially influential accession </a:t>
            </a:r>
            <a:r>
              <a:rPr lang="en-US" sz="1400" dirty="0">
                <a:ea typeface="MS Mincho" panose="02020609040205080304" pitchFamily="49" charset="-128"/>
              </a:rPr>
              <a:t>IRIS_313_9368 or all six </a:t>
            </a:r>
            <a:r>
              <a:rPr lang="en-US" sz="1400" i="1" dirty="0" err="1">
                <a:ea typeface="MS Mincho" panose="02020609040205080304" pitchFamily="49" charset="-128"/>
              </a:rPr>
              <a:t>aus</a:t>
            </a:r>
            <a:r>
              <a:rPr lang="en-US" sz="1400" dirty="0">
                <a:ea typeface="MS Mincho" panose="02020609040205080304" pitchFamily="49" charset="-128"/>
              </a:rPr>
              <a:t> accession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2934" y="391326"/>
            <a:ext cx="5160132" cy="442382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DCE56E8-69C8-4148-9CB8-D11EA1DBBB09}"/>
              </a:ext>
            </a:extLst>
          </p:cNvPr>
          <p:cNvSpPr txBox="1"/>
          <p:nvPr/>
        </p:nvSpPr>
        <p:spPr>
          <a:xfrm>
            <a:off x="1363387" y="5470472"/>
            <a:ext cx="6674741" cy="845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omic prediction of zinc-biofortification potential in rice gene bank accessions</a:t>
            </a:r>
          </a:p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kotondramanan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 et al. (2022) Theoretical and Applied Genetics</a:t>
            </a:r>
          </a:p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author: Matthias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ssuw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issuwa@affrc.go.jp</a:t>
            </a:r>
          </a:p>
        </p:txBody>
      </p:sp>
    </p:spTree>
    <p:extLst>
      <p:ext uri="{BB962C8B-B14F-4D97-AF65-F5344CB8AC3E}">
        <p14:creationId xmlns:p14="http://schemas.microsoft.com/office/powerpoint/2010/main" val="1751038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</TotalTime>
  <Words>69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Juan</cp:lastModifiedBy>
  <cp:revision>33</cp:revision>
  <dcterms:created xsi:type="dcterms:W3CDTF">2021-06-16T10:29:06Z</dcterms:created>
  <dcterms:modified xsi:type="dcterms:W3CDTF">2022-04-12T01:44:20Z</dcterms:modified>
</cp:coreProperties>
</file>